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97" autoAdjust="0"/>
    <p:restoredTop sz="94660"/>
  </p:normalViewPr>
  <p:slideViewPr>
    <p:cSldViewPr snapToGrid="0">
      <p:cViewPr>
        <p:scale>
          <a:sx n="120" d="100"/>
          <a:sy n="120" d="100"/>
        </p:scale>
        <p:origin x="-132" y="29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254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275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003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013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684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976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68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762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280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775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563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257F2-74AF-4BD1-8AA1-1D51860CCA52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B6B3F-86A1-4450-8ADB-1C01DF6526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824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1347895" y="-6593306"/>
            <a:ext cx="8039100" cy="19325722"/>
            <a:chOff x="1155389" y="0"/>
            <a:chExt cx="8039100" cy="19325722"/>
          </a:xfrm>
        </p:grpSpPr>
        <p:grpSp>
          <p:nvGrpSpPr>
            <p:cNvPr id="60" name="Group 59"/>
            <p:cNvGrpSpPr/>
            <p:nvPr/>
          </p:nvGrpSpPr>
          <p:grpSpPr>
            <a:xfrm>
              <a:off x="1155389" y="0"/>
              <a:ext cx="8039100" cy="19325722"/>
              <a:chOff x="1155389" y="0"/>
              <a:chExt cx="8039100" cy="19325722"/>
            </a:xfrm>
          </p:grpSpPr>
          <p:sp>
            <p:nvSpPr>
              <p:cNvPr id="19" name="Rectangle 18"/>
              <p:cNvSpPr/>
              <p:nvPr/>
            </p:nvSpPr>
            <p:spPr>
              <a:xfrm>
                <a:off x="1155389" y="0"/>
                <a:ext cx="8039100" cy="1932572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b="1"/>
              </a:p>
            </p:txBody>
          </p:sp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>
                <a:clrChange>
                  <a:clrFrom>
                    <a:srgbClr val="FF0000"/>
                  </a:clrFrom>
                  <a:clrTo>
                    <a:srgbClr val="FF0000">
                      <a:alpha val="0"/>
                    </a:srgbClr>
                  </a:clrTo>
                </a:clrChange>
              </a:blip>
              <a:srcRect l="18035" t="18257" r="31555" b="2961"/>
              <a:stretch/>
            </p:blipFill>
            <p:spPr>
              <a:xfrm>
                <a:off x="1332283" y="97971"/>
                <a:ext cx="6558714" cy="5763128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3">
                <a:clrChange>
                  <a:clrFrom>
                    <a:srgbClr val="FF0000"/>
                  </a:clrFrom>
                  <a:clrTo>
                    <a:srgbClr val="FF0000">
                      <a:alpha val="0"/>
                    </a:srgbClr>
                  </a:clrTo>
                </a:clrChange>
              </a:blip>
              <a:srcRect l="18498" t="17928" r="31660" b="-164"/>
              <a:stretch/>
            </p:blipFill>
            <p:spPr>
              <a:xfrm>
                <a:off x="1392439" y="5536244"/>
                <a:ext cx="6485022" cy="601579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4">
                <a:clrChange>
                  <a:clrFrom>
                    <a:srgbClr val="FF0000"/>
                  </a:clrFrom>
                  <a:clrTo>
                    <a:srgbClr val="FF0000">
                      <a:alpha val="0"/>
                    </a:srgbClr>
                  </a:clrTo>
                </a:clrChange>
              </a:blip>
              <a:srcRect l="18220" t="20676" r="31994"/>
              <a:stretch/>
            </p:blipFill>
            <p:spPr>
              <a:xfrm>
                <a:off x="1349076" y="11526712"/>
                <a:ext cx="6477753" cy="5802724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5">
                <a:clrChange>
                  <a:clrFrom>
                    <a:srgbClr val="FF0000"/>
                  </a:clrFrom>
                  <a:clrTo>
                    <a:srgbClr val="FF0000">
                      <a:alpha val="0"/>
                    </a:srgbClr>
                  </a:clrTo>
                </a:clrChange>
              </a:blip>
              <a:srcRect l="18128" t="36184" r="32637" b="7895"/>
              <a:stretch/>
            </p:blipFill>
            <p:spPr>
              <a:xfrm>
                <a:off x="1340006" y="15045755"/>
                <a:ext cx="6387265" cy="4078728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 rot="16200000">
                <a:off x="7745142" y="17069648"/>
                <a:ext cx="1371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err="1" smtClean="0"/>
                  <a:t>GlnR</a:t>
                </a:r>
                <a:endParaRPr lang="en-US" sz="1400" b="1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6200000">
                <a:off x="7731992" y="14095385"/>
                <a:ext cx="1371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err="1" smtClean="0"/>
                  <a:t>MlrA</a:t>
                </a:r>
                <a:endParaRPr lang="en-US" sz="14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8103539" y="10893897"/>
                <a:ext cx="82790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/>
                  <a:t>Hg-type </a:t>
                </a:r>
                <a:r>
                  <a:rPr lang="en-US" sz="1400" b="1" dirty="0" err="1" smtClean="0"/>
                  <a:t>MerR</a:t>
                </a:r>
                <a:endParaRPr lang="en-US" sz="1400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7798987" y="8803200"/>
                <a:ext cx="143701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/>
                  <a:t>Uncharacterized </a:t>
                </a:r>
                <a:r>
                  <a:rPr lang="en-US" sz="1400" b="1" dirty="0" err="1" smtClean="0"/>
                  <a:t>MerR</a:t>
                </a:r>
                <a:endParaRPr lang="en-US" sz="1400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7939990" y="6507067"/>
                <a:ext cx="1155007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err="1" smtClean="0"/>
                  <a:t>CueR</a:t>
                </a:r>
                <a:r>
                  <a:rPr lang="en-US" sz="1400" b="1" dirty="0" smtClean="0"/>
                  <a:t>, </a:t>
                </a:r>
                <a:r>
                  <a:rPr lang="en-US" sz="1400" b="1" dirty="0" err="1" smtClean="0"/>
                  <a:t>ZntR</a:t>
                </a:r>
                <a:r>
                  <a:rPr lang="en-US" sz="1400" b="1" dirty="0" smtClean="0"/>
                  <a:t>, </a:t>
                </a:r>
                <a:r>
                  <a:rPr lang="en-US" sz="1400" b="1" dirty="0" err="1" smtClean="0"/>
                  <a:t>PbrR</a:t>
                </a:r>
                <a:endParaRPr lang="en-US" sz="1400" b="1" dirty="0"/>
              </a:p>
            </p:txBody>
          </p:sp>
          <p:cxnSp>
            <p:nvCxnSpPr>
              <p:cNvPr id="21" name="Straight Connector 20"/>
              <p:cNvCxnSpPr/>
              <p:nvPr/>
            </p:nvCxnSpPr>
            <p:spPr>
              <a:xfrm>
                <a:off x="8212339" y="7428196"/>
                <a:ext cx="0" cy="337879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8212339" y="10849488"/>
                <a:ext cx="7925" cy="587974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 flipH="1">
                <a:off x="8212498" y="13681166"/>
                <a:ext cx="8864" cy="127436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8212339" y="16750664"/>
                <a:ext cx="0" cy="949048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 rot="16200000">
                <a:off x="7731992" y="15698048"/>
                <a:ext cx="1371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err="1" smtClean="0"/>
                  <a:t>YwkC</a:t>
                </a:r>
                <a:endParaRPr lang="en-US" sz="1400" b="1" dirty="0"/>
              </a:p>
            </p:txBody>
          </p:sp>
          <p:cxnSp>
            <p:nvCxnSpPr>
              <p:cNvPr id="32" name="Straight Connector 31"/>
              <p:cNvCxnSpPr/>
              <p:nvPr/>
            </p:nvCxnSpPr>
            <p:spPr>
              <a:xfrm>
                <a:off x="8212339" y="15015375"/>
                <a:ext cx="0" cy="167312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/>
              <p:cNvSpPr txBox="1"/>
              <p:nvPr/>
            </p:nvSpPr>
            <p:spPr>
              <a:xfrm rot="16200000">
                <a:off x="7742872" y="18089693"/>
                <a:ext cx="1371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err="1" smtClean="0"/>
                  <a:t>SoxR</a:t>
                </a:r>
                <a:endParaRPr lang="en-US" sz="1400" b="1" dirty="0"/>
              </a:p>
            </p:txBody>
          </p:sp>
          <p:cxnSp>
            <p:nvCxnSpPr>
              <p:cNvPr id="40" name="Straight Connector 39"/>
              <p:cNvCxnSpPr/>
              <p:nvPr/>
            </p:nvCxnSpPr>
            <p:spPr>
              <a:xfrm>
                <a:off x="8212339" y="17757807"/>
                <a:ext cx="0" cy="117157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 rot="60000">
                <a:off x="8205571" y="6191173"/>
                <a:ext cx="18800" cy="11492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 flipH="1">
                <a:off x="8212339" y="3658297"/>
                <a:ext cx="8019" cy="2454963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/>
              <p:cNvSpPr txBox="1"/>
              <p:nvPr/>
            </p:nvSpPr>
            <p:spPr>
              <a:xfrm rot="16200000">
                <a:off x="7387229" y="4815725"/>
                <a:ext cx="20450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/>
                  <a:t>Uncharacterized </a:t>
                </a:r>
                <a:r>
                  <a:rPr lang="en-US" sz="1400" b="1" dirty="0" err="1" smtClean="0"/>
                  <a:t>MerR</a:t>
                </a:r>
                <a:endParaRPr lang="en-US" sz="1400" b="1" dirty="0"/>
              </a:p>
            </p:txBody>
          </p:sp>
          <p:cxnSp>
            <p:nvCxnSpPr>
              <p:cNvPr id="48" name="Straight Connector 47"/>
              <p:cNvCxnSpPr/>
              <p:nvPr/>
            </p:nvCxnSpPr>
            <p:spPr>
              <a:xfrm>
                <a:off x="8212339" y="2036682"/>
                <a:ext cx="8020" cy="1545936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/>
              <p:cNvSpPr txBox="1"/>
              <p:nvPr/>
            </p:nvSpPr>
            <p:spPr>
              <a:xfrm rot="16200000">
                <a:off x="7705375" y="2595209"/>
                <a:ext cx="14248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err="1" smtClean="0"/>
                  <a:t>CueR</a:t>
                </a:r>
                <a:r>
                  <a:rPr lang="en-US" sz="1400" b="1" dirty="0" smtClean="0"/>
                  <a:t>, </a:t>
                </a:r>
                <a:r>
                  <a:rPr lang="en-US" sz="1400" b="1" dirty="0" err="1" smtClean="0"/>
                  <a:t>MerD</a:t>
                </a:r>
                <a:endParaRPr lang="en-US" sz="1400" b="1" dirty="0"/>
              </a:p>
            </p:txBody>
          </p:sp>
          <p:cxnSp>
            <p:nvCxnSpPr>
              <p:cNvPr id="51" name="Straight Connector 50"/>
              <p:cNvCxnSpPr/>
              <p:nvPr/>
            </p:nvCxnSpPr>
            <p:spPr>
              <a:xfrm>
                <a:off x="8208326" y="179807"/>
                <a:ext cx="26072" cy="177466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/>
              <p:cNvSpPr txBox="1"/>
              <p:nvPr/>
            </p:nvSpPr>
            <p:spPr>
              <a:xfrm rot="16200000">
                <a:off x="7716450" y="805529"/>
                <a:ext cx="160208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/>
                  <a:t>Uncharacterized </a:t>
                </a:r>
                <a:r>
                  <a:rPr lang="en-US" sz="1400" b="1" dirty="0" err="1" smtClean="0"/>
                  <a:t>MerR</a:t>
                </a:r>
                <a:endParaRPr lang="en-US" sz="1400" b="1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 rot="16200000">
                <a:off x="7723972" y="12342142"/>
                <a:ext cx="1371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err="1" smtClean="0"/>
                  <a:t>DnaK</a:t>
                </a:r>
                <a:endParaRPr lang="en-US" sz="1400" b="1" dirty="0"/>
              </a:p>
            </p:txBody>
          </p:sp>
          <p:cxnSp>
            <p:nvCxnSpPr>
              <p:cNvPr id="58" name="Straight Connector 57"/>
              <p:cNvCxnSpPr/>
              <p:nvPr/>
            </p:nvCxnSpPr>
            <p:spPr>
              <a:xfrm flipH="1">
                <a:off x="8208142" y="11493839"/>
                <a:ext cx="8864" cy="2052378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/>
            <p:cNvSpPr txBox="1"/>
            <p:nvPr/>
          </p:nvSpPr>
          <p:spPr>
            <a:xfrm>
              <a:off x="6143625" y="1371600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400675" y="9848908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626516" y="4602484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835941" y="5774706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500518" y="5672772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931191" y="8995943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127314" y="9435058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182565" y="7488326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838375" y="1582997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950028" y="5334218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6209660" y="1042139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182565" y="4053958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399206" y="5016933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000251" y="5562196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7278652" y="7379622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131071" y="8895533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967659" y="9324307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6484931" y="9539951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6678415" y="7822659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775081" y="8034264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6300802" y="9754562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6725697" y="5242149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7113581" y="4711009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6612063" y="1473504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6167077" y="4480892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237557" y="5882104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698881" y="8563812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746506" y="8659062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6773322" y="7603641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6314316" y="8355351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6307688" y="8469022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508672" y="8787190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875862" y="9213593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6419366" y="9659313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6360347" y="4908481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5894004" y="5447486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934072" y="6535664"/>
              <a:ext cx="361637" cy="246221"/>
            </a:xfrm>
            <a:prstGeom prst="rect">
              <a:avLst/>
            </a:prstGeom>
            <a:noFill/>
          </p:spPr>
          <p:txBody>
            <a:bodyPr wrap="none" lIns="0" rtlCol="0">
              <a:spAutoFit/>
            </a:bodyPr>
            <a:lstStyle/>
            <a:p>
              <a:r>
                <a:rPr lang="en-US" sz="1000" b="1" dirty="0" err="1" smtClean="0"/>
                <a:t>CueR</a:t>
              </a:r>
              <a:endParaRPr lang="en-US" sz="1200" b="1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815044" y="6536057"/>
              <a:ext cx="194925" cy="338554"/>
            </a:xfrm>
            <a:prstGeom prst="rect">
              <a:avLst/>
            </a:prstGeom>
            <a:noFill/>
          </p:spPr>
          <p:txBody>
            <a:bodyPr wrap="none" lIns="0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632586" y="3517051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5551764" y="2553986"/>
              <a:ext cx="12215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000" b="1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551765" y="2670689"/>
              <a:ext cx="95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4932289" y="2732990"/>
              <a:ext cx="658953" cy="0"/>
            </a:xfrm>
            <a:prstGeom prst="line">
              <a:avLst/>
            </a:prstGeom>
            <a:ln w="127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>
              <a:off x="4932289" y="2847290"/>
              <a:ext cx="658953" cy="0"/>
            </a:xfrm>
            <a:prstGeom prst="line">
              <a:avLst/>
            </a:prstGeom>
            <a:ln w="127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4227439" y="6504890"/>
              <a:ext cx="658953" cy="0"/>
            </a:xfrm>
            <a:prstGeom prst="line">
              <a:avLst/>
            </a:prstGeom>
            <a:ln w="127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/>
            <p:cNvSpPr txBox="1"/>
            <p:nvPr/>
          </p:nvSpPr>
          <p:spPr>
            <a:xfrm>
              <a:off x="5333066" y="6212003"/>
              <a:ext cx="194925" cy="338554"/>
            </a:xfrm>
            <a:prstGeom prst="rect">
              <a:avLst/>
            </a:prstGeom>
            <a:noFill/>
          </p:spPr>
          <p:txBody>
            <a:bodyPr wrap="none" lIns="0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913966" y="6316778"/>
              <a:ext cx="194925" cy="338554"/>
            </a:xfrm>
            <a:prstGeom prst="rect">
              <a:avLst/>
            </a:prstGeom>
            <a:noFill/>
          </p:spPr>
          <p:txBody>
            <a:bodyPr wrap="none" lIns="0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556144" y="6643873"/>
              <a:ext cx="194925" cy="338554"/>
            </a:xfrm>
            <a:prstGeom prst="rect">
              <a:avLst/>
            </a:prstGeom>
            <a:noFill/>
          </p:spPr>
          <p:txBody>
            <a:bodyPr wrap="none" lIns="0" rtlCol="0">
              <a:spAutoFit/>
            </a:bodyPr>
            <a:lstStyle/>
            <a:p>
              <a:r>
                <a:rPr lang="en-US" sz="1600" b="1" dirty="0" smtClean="0"/>
                <a:t>*</a:t>
              </a:r>
              <a:endParaRPr lang="en-US" sz="1600" b="1" dirty="0"/>
            </a:p>
          </p:txBody>
        </p:sp>
        <p:cxnSp>
          <p:nvCxnSpPr>
            <p:cNvPr id="94" name="Straight Connector 93"/>
            <p:cNvCxnSpPr/>
            <p:nvPr/>
          </p:nvCxnSpPr>
          <p:spPr>
            <a:xfrm>
              <a:off x="3913114" y="6819215"/>
              <a:ext cx="658953" cy="0"/>
            </a:xfrm>
            <a:prstGeom prst="line">
              <a:avLst/>
            </a:prstGeom>
            <a:ln w="127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>
              <a:off x="2398639" y="11543615"/>
              <a:ext cx="658953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Oval 2"/>
            <p:cNvSpPr/>
            <p:nvPr/>
          </p:nvSpPr>
          <p:spPr>
            <a:xfrm>
              <a:off x="6207071" y="1963986"/>
              <a:ext cx="180491" cy="161448"/>
            </a:xfrm>
            <a:prstGeom prst="ellipse">
              <a:avLst/>
            </a:prstGeom>
            <a:noFill/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4869477" y="6415996"/>
              <a:ext cx="339195" cy="246221"/>
            </a:xfrm>
            <a:prstGeom prst="rect">
              <a:avLst/>
            </a:prstGeom>
            <a:noFill/>
          </p:spPr>
          <p:txBody>
            <a:bodyPr wrap="none" lIns="0" rtlCol="0">
              <a:spAutoFit/>
            </a:bodyPr>
            <a:lstStyle/>
            <a:p>
              <a:r>
                <a:rPr lang="en-US" sz="1000" b="1" dirty="0" err="1" smtClean="0"/>
                <a:t>ZntR</a:t>
              </a:r>
              <a:endParaRPr lang="en-US" sz="1200" b="1" dirty="0"/>
            </a:p>
          </p:txBody>
        </p:sp>
        <p:sp>
          <p:nvSpPr>
            <p:cNvPr id="96" name="TextBox 95"/>
            <p:cNvSpPr txBox="1"/>
            <p:nvPr/>
          </p:nvSpPr>
          <p:spPr>
            <a:xfrm rot="16200000">
              <a:off x="252012" y="15097978"/>
              <a:ext cx="22808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/>
                <a:t>Non-Metal Regulators</a:t>
              </a:r>
              <a:endParaRPr lang="en-US" sz="1400" b="1" dirty="0"/>
            </a:p>
          </p:txBody>
        </p:sp>
        <p:sp>
          <p:nvSpPr>
            <p:cNvPr id="97" name="TextBox 96"/>
            <p:cNvSpPr txBox="1"/>
            <p:nvPr/>
          </p:nvSpPr>
          <p:spPr>
            <a:xfrm rot="16200000">
              <a:off x="594478" y="5775301"/>
              <a:ext cx="16223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/>
                <a:t>Metal Regulators</a:t>
              </a:r>
              <a:endParaRPr lang="en-US" sz="1400" b="1" dirty="0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819400" y="7095798"/>
              <a:ext cx="238192" cy="3882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5687982" y="2555352"/>
              <a:ext cx="12215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 smtClean="0"/>
                <a:t>MerD</a:t>
              </a:r>
              <a:r>
                <a:rPr lang="en-US" sz="1000" b="1" dirty="0" smtClean="0"/>
                <a:t>  Hg </a:t>
              </a:r>
              <a:r>
                <a:rPr lang="en-US" sz="1000" b="1" dirty="0" smtClean="0"/>
                <a:t>Cd </a:t>
              </a:r>
              <a:r>
                <a:rPr lang="en-US" sz="1000" b="1" dirty="0" err="1" smtClean="0"/>
                <a:t>Pb</a:t>
              </a:r>
              <a:endParaRPr lang="en-US" sz="1000" b="1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5632209" y="2669305"/>
              <a:ext cx="12215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 smtClean="0"/>
                <a:t>MerD</a:t>
              </a:r>
              <a:r>
                <a:rPr lang="en-US" sz="1000" b="1" dirty="0" smtClean="0"/>
                <a:t>  Hg </a:t>
              </a:r>
              <a:r>
                <a:rPr lang="en-US" sz="1000" b="1" dirty="0" smtClean="0"/>
                <a:t>Cd </a:t>
              </a:r>
              <a:r>
                <a:rPr lang="en-US" sz="1000" b="1" dirty="0" err="1" smtClean="0"/>
                <a:t>Pb</a:t>
              </a:r>
              <a:endParaRPr lang="en-US" sz="1000" b="1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4728407" y="3524490"/>
              <a:ext cx="5095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 smtClean="0"/>
                <a:t>CueR</a:t>
              </a:r>
              <a:endParaRPr lang="en-US" sz="1000" b="1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956945" y="6318818"/>
              <a:ext cx="12215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 smtClean="0"/>
                <a:t>PbR</a:t>
              </a:r>
              <a:r>
                <a:rPr lang="en-US" sz="1000" b="1" dirty="0" smtClean="0"/>
                <a:t>  </a:t>
              </a:r>
              <a:r>
                <a:rPr lang="en-US" sz="1000" b="1" dirty="0" err="1" smtClean="0"/>
                <a:t>Pb</a:t>
              </a:r>
              <a:r>
                <a:rPr lang="en-US" sz="1000" b="1" dirty="0" smtClean="0"/>
                <a:t> Co As</a:t>
              </a:r>
              <a:endParaRPr lang="en-US" sz="1000" b="1" dirty="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584632" y="6652279"/>
              <a:ext cx="12215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 smtClean="0"/>
                <a:t>CupR</a:t>
              </a:r>
              <a:r>
                <a:rPr lang="en-US" sz="1000" b="1" dirty="0" smtClean="0"/>
                <a:t>  Ag As </a:t>
              </a:r>
              <a:r>
                <a:rPr lang="en-US" sz="1000" b="1" dirty="0" err="1" smtClean="0"/>
                <a:t>Pb</a:t>
              </a:r>
              <a:endParaRPr lang="en-US" sz="1000" b="1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038542" y="11368890"/>
              <a:ext cx="12215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As</a:t>
              </a:r>
              <a:endParaRPr 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29633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5</TotalTime>
  <Words>88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al Furnholm</dc:creator>
  <cp:lastModifiedBy>Teal Furnholm</cp:lastModifiedBy>
  <cp:revision>29</cp:revision>
  <dcterms:created xsi:type="dcterms:W3CDTF">2014-10-24T22:40:54Z</dcterms:created>
  <dcterms:modified xsi:type="dcterms:W3CDTF">2014-11-03T06:13:52Z</dcterms:modified>
</cp:coreProperties>
</file>